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4D6"/>
    <a:srgbClr val="FFFFFF"/>
    <a:srgbClr val="F4B084"/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0A1B5D5-9B99-4C35-A422-299274C87663}" styleName="Stile medio 1 - Colore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>
        <p:scale>
          <a:sx n="118" d="100"/>
          <a:sy n="118" d="100"/>
        </p:scale>
        <p:origin x="100" y="-2176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48984" y="-21433"/>
            <a:ext cx="46292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able 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actors associated to COVID-19 mortalit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95142" y="35380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430980" y="2517170"/>
            <a:ext cx="314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82874" y="381870"/>
            <a:ext cx="13532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/>
              <a:t>Univariable </a:t>
            </a:r>
            <a:r>
              <a:rPr lang="en-US" sz="1100" b="1" dirty="0"/>
              <a:t>analysi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99353" y="2597360"/>
            <a:ext cx="1470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ultivariable analysis</a:t>
            </a:r>
          </a:p>
        </p:txBody>
      </p:sp>
      <p:graphicFrame>
        <p:nvGraphicFramePr>
          <p:cNvPr id="12" name="Tabella 11">
            <a:extLst>
              <a:ext uri="{FF2B5EF4-FFF2-40B4-BE49-F238E27FC236}">
                <a16:creationId xmlns:a16="http://schemas.microsoft.com/office/drawing/2014/main" id="{4D85D5BD-F2AD-1E8B-27C7-BCD84CA756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4494364"/>
              </p:ext>
            </p:extLst>
          </p:nvPr>
        </p:nvGraphicFramePr>
        <p:xfrm>
          <a:off x="866005" y="619377"/>
          <a:ext cx="3202835" cy="5606265"/>
        </p:xfrm>
        <a:graphic>
          <a:graphicData uri="http://schemas.openxmlformats.org/drawingml/2006/table">
            <a:tbl>
              <a:tblPr firstRow="1"/>
              <a:tblGrid>
                <a:gridCol w="984438">
                  <a:extLst>
                    <a:ext uri="{9D8B030D-6E8A-4147-A177-3AD203B41FA5}">
                      <a16:colId xmlns:a16="http://schemas.microsoft.com/office/drawing/2014/main" val="4284027966"/>
                    </a:ext>
                  </a:extLst>
                </a:gridCol>
                <a:gridCol w="296696">
                  <a:extLst>
                    <a:ext uri="{9D8B030D-6E8A-4147-A177-3AD203B41FA5}">
                      <a16:colId xmlns:a16="http://schemas.microsoft.com/office/drawing/2014/main" val="1569674685"/>
                    </a:ext>
                  </a:extLst>
                </a:gridCol>
                <a:gridCol w="640567">
                  <a:extLst>
                    <a:ext uri="{9D8B030D-6E8A-4147-A177-3AD203B41FA5}">
                      <a16:colId xmlns:a16="http://schemas.microsoft.com/office/drawing/2014/main" val="2498361171"/>
                    </a:ext>
                  </a:extLst>
                </a:gridCol>
                <a:gridCol w="640567">
                  <a:extLst>
                    <a:ext uri="{9D8B030D-6E8A-4147-A177-3AD203B41FA5}">
                      <a16:colId xmlns:a16="http://schemas.microsoft.com/office/drawing/2014/main" val="2234203051"/>
                    </a:ext>
                  </a:extLst>
                </a:gridCol>
                <a:gridCol w="640567">
                  <a:extLst>
                    <a:ext uri="{9D8B030D-6E8A-4147-A177-3AD203B41FA5}">
                      <a16:colId xmlns:a16="http://schemas.microsoft.com/office/drawing/2014/main" val="3456647395"/>
                    </a:ext>
                  </a:extLst>
                </a:gridCol>
              </a:tblGrid>
              <a:tr h="115849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Variables</a:t>
                      </a:r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-</a:t>
                      </a:r>
                      <a:r>
                        <a:rPr lang="it-IT" sz="800" b="0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value</a:t>
                      </a:r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5% CI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3003003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er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645004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x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106140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3313315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6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6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493285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6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1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1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1137569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70 year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7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6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28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2850373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-69 year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2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566798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-50 year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84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2119425"/>
                  </a:ext>
                </a:extLst>
              </a:tr>
              <a:tr h="142846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orbidities</a:t>
                      </a:r>
                      <a:endParaRPr lang="it-IT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986489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-1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84343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+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4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448990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eas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805032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4818488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L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0180156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HL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6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8367153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5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0468198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1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0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8517764"/>
                  </a:ext>
                </a:extLst>
              </a:tr>
              <a:tr h="125068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us diseas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5473558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bl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6289236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v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07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6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28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7428621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 onset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257142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n-Jun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‘22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985649"/>
                  </a:ext>
                </a:extLst>
              </a:tr>
              <a:tr h="150076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l–</a:t>
                      </a:r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‘22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0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8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4214286"/>
                  </a:ext>
                </a:extLst>
              </a:tr>
              <a:tr h="149087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l–</a:t>
                      </a:r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‘23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4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1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017310"/>
                  </a:ext>
                </a:extLst>
              </a:tr>
              <a:tr h="163513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VID-19 symptom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4980702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ymptomatic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3014775"/>
                  </a:ext>
                </a:extLst>
              </a:tr>
              <a:tr h="148743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pulmonary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0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7616113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lmonary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0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271976"/>
                  </a:ext>
                </a:extLst>
              </a:tr>
              <a:tr h="157930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spitalization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6884679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me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4345229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spital. ICU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2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5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644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3331498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verity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759691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4258972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5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0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8889776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9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4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1674872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78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0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19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2993652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4136491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386227"/>
                  </a:ext>
                </a:extLst>
              </a:tr>
              <a:tr h="153785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-immuno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92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7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856967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meth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ting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gents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16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91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6292887"/>
                  </a:ext>
                </a:extLst>
              </a:tr>
              <a:tr h="11584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 therapy</a:t>
                      </a:r>
                    </a:p>
                  </a:txBody>
                  <a:tcPr marL="4319" marR="4319" marT="43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4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83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8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37</a:t>
                      </a: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3762884"/>
                  </a:ext>
                </a:extLst>
              </a:tr>
            </a:tbl>
          </a:graphicData>
        </a:graphic>
      </p:graphicFrame>
      <p:graphicFrame>
        <p:nvGraphicFramePr>
          <p:cNvPr id="16" name="Tabella 15">
            <a:extLst>
              <a:ext uri="{FF2B5EF4-FFF2-40B4-BE49-F238E27FC236}">
                <a16:creationId xmlns:a16="http://schemas.microsoft.com/office/drawing/2014/main" id="{F71651F0-602F-C112-B548-697CADD141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7745736"/>
              </p:ext>
            </p:extLst>
          </p:nvPr>
        </p:nvGraphicFramePr>
        <p:xfrm>
          <a:off x="4749640" y="2885912"/>
          <a:ext cx="3492500" cy="958374"/>
        </p:xfrm>
        <a:graphic>
          <a:graphicData uri="http://schemas.openxmlformats.org/drawingml/2006/table">
            <a:tbl>
              <a:tblPr/>
              <a:tblGrid>
                <a:gridCol w="751792">
                  <a:extLst>
                    <a:ext uri="{9D8B030D-6E8A-4147-A177-3AD203B41FA5}">
                      <a16:colId xmlns:a16="http://schemas.microsoft.com/office/drawing/2014/main" val="2925049515"/>
                    </a:ext>
                  </a:extLst>
                </a:gridCol>
                <a:gridCol w="685177">
                  <a:extLst>
                    <a:ext uri="{9D8B030D-6E8A-4147-A177-3AD203B41FA5}">
                      <a16:colId xmlns:a16="http://schemas.microsoft.com/office/drawing/2014/main" val="2259741864"/>
                    </a:ext>
                  </a:extLst>
                </a:gridCol>
                <a:gridCol w="685177">
                  <a:extLst>
                    <a:ext uri="{9D8B030D-6E8A-4147-A177-3AD203B41FA5}">
                      <a16:colId xmlns:a16="http://schemas.microsoft.com/office/drawing/2014/main" val="1230440472"/>
                    </a:ext>
                  </a:extLst>
                </a:gridCol>
                <a:gridCol w="685177">
                  <a:extLst>
                    <a:ext uri="{9D8B030D-6E8A-4147-A177-3AD203B41FA5}">
                      <a16:colId xmlns:a16="http://schemas.microsoft.com/office/drawing/2014/main" val="1157635669"/>
                    </a:ext>
                  </a:extLst>
                </a:gridCol>
                <a:gridCol w="685177">
                  <a:extLst>
                    <a:ext uri="{9D8B030D-6E8A-4147-A177-3AD203B41FA5}">
                      <a16:colId xmlns:a16="http://schemas.microsoft.com/office/drawing/2014/main" val="574824271"/>
                    </a:ext>
                  </a:extLst>
                </a:gridCol>
              </a:tblGrid>
              <a:tr h="196850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0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Variables</a:t>
                      </a:r>
                      <a:endParaRPr lang="it-IT" sz="11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9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9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it-IT" sz="9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95% CI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9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2498810"/>
                  </a:ext>
                </a:extLst>
              </a:tr>
              <a:tr h="153194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w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pp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9933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3381890"/>
                  </a:ext>
                </a:extLst>
              </a:tr>
              <a:tr h="196850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v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3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2295158"/>
                  </a:ext>
                </a:extLst>
              </a:tr>
              <a:tr h="214630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8876956"/>
                  </a:ext>
                </a:extLst>
              </a:tr>
              <a:tr h="196850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70 year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6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F7964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44841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1802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0</Words>
  <Application>Microsoft Office PowerPoint</Application>
  <PresentationFormat>Presentazione su schermo (4:3)</PresentationFormat>
  <Paragraphs>23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12</cp:revision>
  <dcterms:created xsi:type="dcterms:W3CDTF">2024-10-12T13:22:48Z</dcterms:created>
  <dcterms:modified xsi:type="dcterms:W3CDTF">2025-05-25T19:59:26Z</dcterms:modified>
</cp:coreProperties>
</file>